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 varScale="1">
        <p:scale>
          <a:sx n="70" d="100"/>
          <a:sy n="70" d="100"/>
        </p:scale>
        <p:origin x="-112" y="-28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520E0E-1FE5-0948-806F-ECE3643D530C}" type="datetimeFigureOut">
              <a:t>3/10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171D59-6E39-C943-84F0-5B7FCF8536FD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78870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520E0E-1FE5-0948-806F-ECE3643D530C}" type="datetimeFigureOut">
              <a:t>3/10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171D59-6E39-C943-84F0-5B7FCF8536FD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63156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520E0E-1FE5-0948-806F-ECE3643D530C}" type="datetimeFigureOut">
              <a:t>3/10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171D59-6E39-C943-84F0-5B7FCF8536FD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41657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520E0E-1FE5-0948-806F-ECE3643D530C}" type="datetimeFigureOut">
              <a:t>3/10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171D59-6E39-C943-84F0-5B7FCF8536FD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87942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520E0E-1FE5-0948-806F-ECE3643D530C}" type="datetimeFigureOut">
              <a:t>3/10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171D59-6E39-C943-84F0-5B7FCF8536FD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50985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520E0E-1FE5-0948-806F-ECE3643D530C}" type="datetimeFigureOut">
              <a:t>3/10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171D59-6E39-C943-84F0-5B7FCF8536FD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59711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520E0E-1FE5-0948-806F-ECE3643D530C}" type="datetimeFigureOut">
              <a:t>3/10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171D59-6E39-C943-84F0-5B7FCF8536FD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94865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520E0E-1FE5-0948-806F-ECE3643D530C}" type="datetimeFigureOut">
              <a:t>3/10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171D59-6E39-C943-84F0-5B7FCF8536FD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93632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520E0E-1FE5-0948-806F-ECE3643D530C}" type="datetimeFigureOut">
              <a:t>3/10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171D59-6E39-C943-84F0-5B7FCF8536FD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32730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520E0E-1FE5-0948-806F-ECE3643D530C}" type="datetimeFigureOut">
              <a:t>3/10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171D59-6E39-C943-84F0-5B7FCF8536FD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30734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520E0E-1FE5-0948-806F-ECE3643D530C}" type="datetimeFigureOut">
              <a:t>3/10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171D59-6E39-C943-84F0-5B7FCF8536FD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56213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520E0E-1FE5-0948-806F-ECE3643D530C}" type="datetimeFigureOut">
              <a:t>3/10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171D59-6E39-C943-84F0-5B7FCF8536FD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72670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46799256"/>
              </p:ext>
            </p:extLst>
          </p:nvPr>
        </p:nvGraphicFramePr>
        <p:xfrm>
          <a:off x="320571" y="325723"/>
          <a:ext cx="8507480" cy="6496275"/>
        </p:xfrm>
        <a:graphic>
          <a:graphicData uri="http://schemas.openxmlformats.org/drawingml/2006/table">
            <a:tbl>
              <a:tblPr/>
              <a:tblGrid>
                <a:gridCol w="1860088"/>
                <a:gridCol w="780039"/>
                <a:gridCol w="888042"/>
                <a:gridCol w="780039"/>
                <a:gridCol w="780039"/>
                <a:gridCol w="780039"/>
                <a:gridCol w="780039"/>
                <a:gridCol w="780039"/>
                <a:gridCol w="1079116"/>
              </a:tblGrid>
              <a:tr h="12219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Group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Time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Experiment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M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N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B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M&gt;B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M~B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Total cells (n)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</a:tr>
              <a:tr h="126955">
                <a:tc rowSpan="8">
                  <a:txBody>
                    <a:bodyPr/>
                    <a:lstStyle/>
                    <a:p>
                      <a:pPr algn="ctr" fontAlgn="ctr"/>
                      <a:r>
                        <a:rPr lang="is-I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Rpa190</a:t>
                      </a:r>
                      <a:r>
                        <a:rPr lang="is-IS" sz="1100" b="1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+</a:t>
                      </a:r>
                      <a:r>
                        <a:rPr lang="is-I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Gar1-GFP (23</a:t>
                      </a:r>
                      <a:r>
                        <a:rPr lang="is-IS" sz="1100" b="1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  <a:r>
                        <a:rPr lang="is-I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C)</a:t>
                      </a:r>
                    </a:p>
                  </a:txBody>
                  <a:tcPr marL="7935" marR="7935" marT="7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T0</a:t>
                      </a:r>
                    </a:p>
                  </a:txBody>
                  <a:tcPr marL="7935" marR="7935" marT="7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Expt1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55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1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4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70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219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Expt2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u-RU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34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5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4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43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219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 </a:t>
                      </a:r>
                    </a:p>
                  </a:txBody>
                  <a:tcPr marL="7935" marR="7935" marT="7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 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 </a:t>
                      </a:r>
                    </a:p>
                  </a:txBody>
                  <a:tcPr marL="7935" marR="7935" marT="793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 </a:t>
                      </a:r>
                    </a:p>
                  </a:txBody>
                  <a:tcPr marL="7935" marR="7935" marT="793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 </a:t>
                      </a:r>
                    </a:p>
                  </a:txBody>
                  <a:tcPr marL="7935" marR="7935" marT="793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 </a:t>
                      </a:r>
                    </a:p>
                  </a:txBody>
                  <a:tcPr marL="7935" marR="7935" marT="793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 </a:t>
                      </a:r>
                    </a:p>
                  </a:txBody>
                  <a:tcPr marL="7935" marR="7935" marT="793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 </a:t>
                      </a:r>
                    </a:p>
                  </a:txBody>
                  <a:tcPr marL="7935" marR="7935" marT="793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219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T2</a:t>
                      </a:r>
                    </a:p>
                  </a:txBody>
                  <a:tcPr marL="7935" marR="7935" marT="7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Expt1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76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3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80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219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 </a:t>
                      </a:r>
                    </a:p>
                  </a:txBody>
                  <a:tcPr marL="7935" marR="7935" marT="7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Expt2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81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3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86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219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8">
                  <a:txBody>
                    <a:bodyPr/>
                    <a:lstStyle/>
                    <a:p>
                      <a:pPr algn="ctr" fontAlgn="ctr"/>
                      <a:r>
                        <a:rPr lang="sk-SK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 </a:t>
                      </a:r>
                    </a:p>
                  </a:txBody>
                  <a:tcPr marL="7935" marR="7935" marT="7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2219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T4</a:t>
                      </a:r>
                    </a:p>
                  </a:txBody>
                  <a:tcPr marL="7935" marR="7935" marT="7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Expt1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96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3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01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219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Expt2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69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3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3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uk-UA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77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2195">
                <a:tc rowSpan="6"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Arrested (36</a:t>
                      </a:r>
                      <a:r>
                        <a:rPr lang="en-US" sz="1100" b="1" i="0" u="none" strike="noStrike" baseline="3000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C)</a:t>
                      </a:r>
                    </a:p>
                  </a:txBody>
                  <a:tcPr marL="7935" marR="7935" marT="7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Time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Experiment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M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N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B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M&gt;B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M~B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Total cells (n)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</a:tr>
              <a:tr h="12219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is-I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T2</a:t>
                      </a:r>
                    </a:p>
                  </a:txBody>
                  <a:tcPr marL="7935" marR="7935" marT="7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Expt1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70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9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3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94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219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Expt2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71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6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80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219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8">
                  <a:txBody>
                    <a:bodyPr/>
                    <a:lstStyle/>
                    <a:p>
                      <a:pPr algn="ctr" fontAlgn="b"/>
                      <a:r>
                        <a:rPr lang="sk-SK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 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2219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T4</a:t>
                      </a:r>
                    </a:p>
                  </a:txBody>
                  <a:tcPr marL="7935" marR="7935" marT="7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Expt1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76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7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7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00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219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Expt2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80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3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8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2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03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2195">
                <a:tc gridSpan="9">
                  <a:txBody>
                    <a:bodyPr/>
                    <a:lstStyle/>
                    <a:p>
                      <a:pPr algn="ctr" fontAlgn="b"/>
                      <a:r>
                        <a:rPr lang="sk-SK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 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2219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Group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Time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Experiment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M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N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B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M&gt;B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M~B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Total cells (n)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</a:tr>
              <a:tr h="122195">
                <a:tc rowSpan="12">
                  <a:txBody>
                    <a:bodyPr/>
                    <a:lstStyle/>
                    <a:p>
                      <a:pPr algn="ctr" fontAlgn="ctr"/>
                      <a:r>
                        <a:rPr lang="is-IS" sz="11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rpa190-3 </a:t>
                      </a:r>
                      <a:r>
                        <a:rPr lang="is-I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Gar1-GFP (23</a:t>
                      </a:r>
                      <a:r>
                        <a:rPr lang="is-IS" sz="1100" b="1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  <a:r>
                        <a:rPr lang="is-I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C)</a:t>
                      </a:r>
                    </a:p>
                  </a:txBody>
                  <a:tcPr marL="7935" marR="7935" marT="7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T0</a:t>
                      </a:r>
                    </a:p>
                  </a:txBody>
                  <a:tcPr marL="7935" marR="7935" marT="7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Expt1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99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7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6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13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219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Expt2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03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3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4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30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219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 </a:t>
                      </a:r>
                    </a:p>
                  </a:txBody>
                  <a:tcPr marL="7935" marR="7935" marT="7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Expt3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86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8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2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17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219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8">
                  <a:txBody>
                    <a:bodyPr/>
                    <a:lstStyle/>
                    <a:p>
                      <a:pPr algn="ctr" fontAlgn="ctr"/>
                      <a:r>
                        <a:rPr lang="sk-SK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 </a:t>
                      </a:r>
                    </a:p>
                  </a:txBody>
                  <a:tcPr marL="7935" marR="7935" marT="7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2219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T2</a:t>
                      </a:r>
                    </a:p>
                  </a:txBody>
                  <a:tcPr marL="7935" marR="7935" marT="7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Expt1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04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8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4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16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219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 </a:t>
                      </a:r>
                    </a:p>
                  </a:txBody>
                  <a:tcPr marL="7935" marR="7935" marT="7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Expt2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76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35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3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3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17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219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 </a:t>
                      </a:r>
                    </a:p>
                  </a:txBody>
                  <a:tcPr marL="7935" marR="7935" marT="7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Expt3</a:t>
                      </a:r>
                    </a:p>
                  </a:txBody>
                  <a:tcPr marL="7935" marR="7935" marT="793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80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48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3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41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219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sk-SK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 </a:t>
                      </a:r>
                    </a:p>
                  </a:txBody>
                  <a:tcPr marL="7935" marR="7935" marT="7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sk-SK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 </a:t>
                      </a:r>
                    </a:p>
                  </a:txBody>
                  <a:tcPr marL="7935" marR="7935" marT="7935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 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 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 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 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 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 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219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T4</a:t>
                      </a:r>
                    </a:p>
                  </a:txBody>
                  <a:tcPr marL="7935" marR="7935" marT="7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Expt1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00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0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4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5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19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219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Expt2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69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32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6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9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16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219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 </a:t>
                      </a:r>
                    </a:p>
                  </a:txBody>
                  <a:tcPr marL="7935" marR="7935" marT="7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Expt3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75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50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3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5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33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219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 </a:t>
                      </a:r>
                    </a:p>
                  </a:txBody>
                  <a:tcPr marL="7935" marR="7935" marT="7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 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 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 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 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 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 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 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2195">
                <a:tc rowSpan="8"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Arrested (36</a:t>
                      </a:r>
                      <a:r>
                        <a:rPr lang="en-US" sz="1100" b="1" i="0" u="none" strike="noStrike" baseline="3000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C)</a:t>
                      </a:r>
                    </a:p>
                  </a:txBody>
                  <a:tcPr marL="7935" marR="7935" marT="7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Time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Experiment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M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N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B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M&gt;B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M~B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Total cells (n)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</a:tr>
              <a:tr h="12219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is-I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T2</a:t>
                      </a:r>
                    </a:p>
                  </a:txBody>
                  <a:tcPr marL="7935" marR="7935" marT="7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Expt1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10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4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7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33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219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Expt2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82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3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8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6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uk-UA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39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219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Expt3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71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5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uk-UA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39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1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tr-TR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26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219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 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 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 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 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 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 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 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 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219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T4</a:t>
                      </a:r>
                    </a:p>
                  </a:txBody>
                  <a:tcPr marL="7935" marR="7935" marT="79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Expt1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56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4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61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7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48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219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Expt2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64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6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44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7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uk-UA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51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219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Expt3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40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8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67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3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38</a:t>
                      </a:r>
                    </a:p>
                  </a:txBody>
                  <a:tcPr marL="7935" marR="7935" marT="793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233399" y="17946"/>
            <a:ext cx="38439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/>
                <a:cs typeface="Arial"/>
              </a:rPr>
              <a:t>S4 Table: Data summary table for figure 3G   </a:t>
            </a:r>
            <a:endParaRPr lang="en-US" sz="1400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5555814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285</Words>
  <Application>Microsoft Macintosh PowerPoint</Application>
  <PresentationFormat>On-screen Show (4:3)</PresentationFormat>
  <Paragraphs>26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Case Western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an Tartakoff</dc:creator>
  <cp:lastModifiedBy>Alan Tartakoff</cp:lastModifiedBy>
  <cp:revision>2</cp:revision>
  <dcterms:created xsi:type="dcterms:W3CDTF">2017-03-10T17:53:16Z</dcterms:created>
  <dcterms:modified xsi:type="dcterms:W3CDTF">2017-03-10T17:57:42Z</dcterms:modified>
</cp:coreProperties>
</file>